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31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371EE0-0DA6-4804-9C9F-5FCE99699F94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156679-E9BE-4149-9EC3-6E513673035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821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EB49A1-8651-4BD4-9A7C-00D721184A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2A7FFB0-0868-4FF7-A1B9-BFD72B93F3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48EC15-0069-4F0D-9453-CB3E66C72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22AEEC-012B-4C95-927F-DD7290D48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4D2A45-07BE-446D-8A70-839B785AE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396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6B2642-E435-45BC-BBA1-E6C73C7BEC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89B5176-AC2C-4F46-B42B-0F0177EBA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D351CD-B841-4596-A831-81A8C38EF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D30C9F-6789-414A-BD32-CF57B007F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DCF376-A068-41EB-8ED6-305B0EDF9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9080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43CB8CB-7621-497E-86F8-B875415402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42AF77C-DCF9-4606-A531-13C6F849B8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D76B68-1B85-4675-9064-5E9C3B5D8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565C91-7826-4394-8878-5D485E6B7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34D441-77EA-4F88-B2DC-1EAE50DD0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4168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2766ED-9C08-485E-A48C-874418C1C0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C76405-B3C2-4C5C-A4F5-EC2EAE7A9C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310684-CFF9-4FDA-9604-8ECA1C9A3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8C32AB-5E9D-4CE7-8B4F-5F7290AA6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9F0CD9-B754-419E-BAD7-9ED6B3AF5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4235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E9DB67-C311-4BC9-9A9A-F003986A6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6584CEC-E3C6-4A81-A007-F8612585F0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45762F-CA61-4BE5-A7A8-801F7D78A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1E3F22-D4AE-40CA-B47F-B6AD1F11E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B4028F-FD31-4AD2-999D-74F8BFE61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57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82C49D-10FF-4865-A298-742DC1414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5943FC-3962-42BB-B3CF-32617C01D7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C2A02D1-0F50-4598-A756-3BEC0C51F5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F3AEB1-66EB-4D6E-8435-FECC7FF29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B7F4A3-0863-4D14-A904-E0861C90E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76AF74-0142-4BF6-8C4C-9295D9433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1692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7A332C-4C19-4026-8E67-E5EB56C18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1E838A-2A11-4057-AAA8-BD3158D545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B390356-E222-4EEA-849D-8FBF4040E0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1938302-A081-4FFE-ACCC-83C61368FF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8A17436-8127-4D49-B87C-EFA22C0B46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C9A2F87-4D24-49E7-9993-6E15D7395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A40DD58-1639-4265-9904-1EB84DA26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060ED0B-6B83-4B0C-A4C9-33267B609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7077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625415-3C0A-4862-B67B-B7D4E63BDF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0F3747E-7E6F-4958-AFBA-04EBDF8CF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023832C-28D5-45CA-816F-3DBF1EDA3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6DA9051-3881-4A59-A0AC-0200449C7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146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44D29C7-4909-4476-A010-BF2868101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C63B9D2-36B8-4C68-AAA2-FCC8FE956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48DE2DA-A9A6-480F-9860-E4566ABDA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6573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7CB355-6CBD-43FD-95ED-AA9E5BF0C4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6B3509C-7BFF-4C2E-93B6-283C0A7A2E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216735E-4657-46B9-A3FD-BB46E3FCCA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58C6EBB-7520-4742-A313-32030E4A1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028231A-1947-4AAC-88F3-0A30A5EDB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187E90F-DDC7-4E83-8A10-B5A6136BB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9269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9646B2-8C95-42F6-B11C-2DE863C93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25D159-B717-4317-A4E0-AFDFE63D98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09C9E6-7F4B-4F61-BD0A-E36DA684BF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06BBF3-96B9-4E71-B747-D9A389DAD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1E20A0A-2ED2-48B4-BF83-3829BEE91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8929E6-A9B1-4A10-9F5A-3EFEAF855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668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0FBB517-65C5-4318-B715-217FC13B37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8449F7-540D-4BAF-A736-10C1D48195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88CB33-C91E-4BDC-8A28-73F30BBFAF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B154DF-6543-41B2-B307-77B274F8E5C3}" type="datetimeFigureOut">
              <a:rPr lang="zh-CN" altLang="en-US" smtClean="0"/>
              <a:t>2023/6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BE7EDF-F545-4B6A-BFD4-A7FFD1D0BE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8BB361-1D5F-4973-A063-9829B3AAE4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AE2DC-33B0-41E7-9BB7-07AF287062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652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58D6A47D-873F-49E8-9C3E-EF923DF8F2FF}"/>
              </a:ext>
            </a:extLst>
          </p:cNvPr>
          <p:cNvSpPr txBox="1"/>
          <p:nvPr/>
        </p:nvSpPr>
        <p:spPr>
          <a:xfrm>
            <a:off x="1422400" y="7193448"/>
            <a:ext cx="4165601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kern="100" dirty="0" smtClean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ure </a:t>
            </a:r>
            <a:r>
              <a:rPr lang="en-US" altLang="zh-CN" sz="1000" b="1" kern="100" dirty="0" smtClean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4</a:t>
            </a:r>
            <a:r>
              <a:rPr lang="en-US" altLang="zh-CN" sz="1000" kern="100" dirty="0" smtClean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rrelation matrix (Pearson’s R</a:t>
            </a:r>
            <a:r>
              <a:rPr lang="en-US" altLang="zh-CN" sz="10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values) between different fatty acid components of Camellia oil. White to blue color represent negative correlation while white to red color represent positive correlation. Values labeled with asterisk (*) are significant at </a:t>
            </a:r>
            <a:r>
              <a:rPr lang="en-US" altLang="zh-CN" sz="10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&lt; 0.05. </a:t>
            </a:r>
            <a:endParaRPr lang="zh-CN" altLang="zh-CN" sz="10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470025" y="504483"/>
            <a:ext cx="3162247" cy="6415296"/>
            <a:chOff x="161925" y="161583"/>
            <a:chExt cx="3162247" cy="6415296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DE95BE34-0A89-404E-B5F7-0625B29FD9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9601" r="13071" b="3315"/>
            <a:stretch/>
          </p:blipFill>
          <p:spPr>
            <a:xfrm>
              <a:off x="276052" y="2398776"/>
              <a:ext cx="2556000" cy="1944000"/>
            </a:xfrm>
            <a:prstGeom prst="rect">
              <a:avLst/>
            </a:prstGeom>
          </p:spPr>
        </p:pic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AE99AF1-67B8-42FB-94FD-6B23208B166D}"/>
                </a:ext>
              </a:extLst>
            </p:cNvPr>
            <p:cNvSpPr txBox="1"/>
            <p:nvPr/>
          </p:nvSpPr>
          <p:spPr>
            <a:xfrm>
              <a:off x="659216" y="2372812"/>
              <a:ext cx="1868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. </a:t>
              </a:r>
              <a:r>
                <a:rPr lang="en-US" altLang="zh-CN" sz="10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eiocarpa</a:t>
              </a:r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var </a:t>
              </a:r>
              <a:r>
                <a:rPr lang="en-US" altLang="zh-CN" sz="10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ngguo</a:t>
              </a:r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D59D50AD-F706-4B98-9CD0-A5599E8D35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809" b="3172"/>
            <a:stretch/>
          </p:blipFill>
          <p:spPr>
            <a:xfrm>
              <a:off x="276052" y="341730"/>
              <a:ext cx="3048120" cy="1980000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32EDDA7-7426-4520-97AD-A5397931322C}"/>
                </a:ext>
              </a:extLst>
            </p:cNvPr>
            <p:cNvSpPr txBox="1"/>
            <p:nvPr/>
          </p:nvSpPr>
          <p:spPr>
            <a:xfrm>
              <a:off x="695814" y="342900"/>
              <a:ext cx="1868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. </a:t>
              </a:r>
              <a:r>
                <a:rPr lang="en-US" altLang="zh-CN" sz="10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eiocarpa</a:t>
              </a:r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var </a:t>
              </a:r>
              <a:r>
                <a:rPr lang="en-US" altLang="zh-CN" sz="10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Qingguo</a:t>
              </a:r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B923494E-BD69-4399-8377-2677EF1FBD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8831" r="13811" b="1638"/>
            <a:stretch/>
          </p:blipFill>
          <p:spPr>
            <a:xfrm>
              <a:off x="259365" y="4416879"/>
              <a:ext cx="2550016" cy="2160000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757A9739-B1DA-4BFA-AA58-45A8B7810820}"/>
                </a:ext>
              </a:extLst>
            </p:cNvPr>
            <p:cNvSpPr txBox="1"/>
            <p:nvPr/>
          </p:nvSpPr>
          <p:spPr>
            <a:xfrm>
              <a:off x="672690" y="4435929"/>
              <a:ext cx="1868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. oleifera cv Min 43 </a:t>
              </a:r>
              <a:endParaRPr lang="zh-CN" alt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9C45190-E323-41AF-8834-0B3A0613B53D}"/>
                </a:ext>
              </a:extLst>
            </p:cNvPr>
            <p:cNvSpPr txBox="1"/>
            <p:nvPr/>
          </p:nvSpPr>
          <p:spPr>
            <a:xfrm>
              <a:off x="165100" y="4267201"/>
              <a:ext cx="283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AAB554BE-164D-412D-A5D4-03A855EEF6A3}"/>
                </a:ext>
              </a:extLst>
            </p:cNvPr>
            <p:cNvSpPr txBox="1"/>
            <p:nvPr/>
          </p:nvSpPr>
          <p:spPr>
            <a:xfrm>
              <a:off x="161925" y="161583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E68644C7-7EB5-44DB-899B-8768B33E7B9D}"/>
                </a:ext>
              </a:extLst>
            </p:cNvPr>
            <p:cNvSpPr txBox="1"/>
            <p:nvPr/>
          </p:nvSpPr>
          <p:spPr>
            <a:xfrm>
              <a:off x="168275" y="2212633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12929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2</TotalTime>
  <Words>67</Words>
  <Application>Microsoft Office PowerPoint</Application>
  <PresentationFormat>A4 纸张(210x297 毫米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Yi</dc:creator>
  <cp:lastModifiedBy>user</cp:lastModifiedBy>
  <cp:revision>53</cp:revision>
  <dcterms:created xsi:type="dcterms:W3CDTF">2021-03-19T13:01:49Z</dcterms:created>
  <dcterms:modified xsi:type="dcterms:W3CDTF">2023-06-04T03:12:31Z</dcterms:modified>
</cp:coreProperties>
</file>